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EFB2566-7A9E-47FE-8111-81AF491D9182}" v="1" dt="2025-11-24T12:47:49.13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944"/>
    <p:restoredTop sz="94582"/>
  </p:normalViewPr>
  <p:slideViewPr>
    <p:cSldViewPr snapToGrid="0">
      <p:cViewPr varScale="1">
        <p:scale>
          <a:sx n="50" d="100"/>
          <a:sy n="50" d="100"/>
        </p:scale>
        <p:origin x="97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88938A-3B66-121E-72C4-58426BAE793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B6D9B1F-1335-4E31-D18E-2D63F5CE381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5CFF9D-DD2E-97DC-4806-F550A906F5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75693-053D-E74E-ABFA-8D0D18AD80CD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CB0E8C-2C7A-A23F-D544-AF599C1125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A83C15-0823-107E-B0A5-FE77F317FB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DBB0-6E86-1F4A-9056-49B47FD18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59549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98AF1C-B842-8F8E-ACE8-7C5C8D4622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817C50A-A783-7418-9357-89E1B5FF0E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80A905-25A5-F998-40C3-795FD6DCAF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75693-053D-E74E-ABFA-8D0D18AD80CD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AE9038-2977-8227-3AE7-571DFB70BF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19C5F3-A2F0-76E6-21FE-4AEA524C40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DBB0-6E86-1F4A-9056-49B47FD18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1310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E191662-BFC8-16EA-D444-2F2F22912EE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B092A11-073D-E170-F500-7C438298C5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6416FF-B204-DF13-09A5-E8872A5E75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75693-053D-E74E-ABFA-8D0D18AD80CD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4B88A2-22A2-2AAF-BB23-03CF5CA09C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B9A96F-4A36-C4E4-2EF0-9D5E0BB65C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DBB0-6E86-1F4A-9056-49B47FD18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460851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13630015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9F5D47-4EE5-1061-0F6A-35A7949DC0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94A89F-E87E-9258-3BAC-D6098684813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0384AD-E571-DF45-949F-0BEED6C4FC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75693-053D-E74E-ABFA-8D0D18AD80CD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DF3EDC-0374-D1E4-BEE0-DC3DEDB473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BCFF9A-D7A8-E138-F661-1B1C4BE466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DBB0-6E86-1F4A-9056-49B47FD18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44619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E86490-EB76-A481-A916-68C99F0A8F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02614A4-21D1-433E-6761-241D8EBFA0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C35D13-0DBD-8F12-5BF6-CDFB63C2C0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75693-053D-E74E-ABFA-8D0D18AD80CD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FC57F3-CE47-EC2C-8060-4DAA69783F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394BE9-25B4-9CF3-747E-C83D56AE5F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DBB0-6E86-1F4A-9056-49B47FD18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54365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894ADF-E8E9-BBEA-44FA-BEA7DE8D0D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5CD7BA-FE80-DEA5-183B-DBDC1B0FCAF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CDA16D2-D4C8-308B-1B9E-0FDDDD3412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8623EE-AFAA-5EB5-74FE-CD597DC5C5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75693-053D-E74E-ABFA-8D0D18AD80CD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B4BB0B-6577-8953-6AA2-3BD2AD6672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08EFD9-631A-A57E-845F-529A5A7585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DBB0-6E86-1F4A-9056-49B47FD18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9957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3371A4-DE4C-5F9F-07CE-D0BAE7788A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B8AD69-E653-6354-C1B8-CF3052C98A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496B645-3A38-E6ED-1EEC-9701421260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439A26A-0CA5-9431-41CF-D2B340B8021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1ACFF75-7A85-6A03-19CA-DA4C0A0C45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AA23A65-22BB-6E4B-5AF2-6254F116E7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75693-053D-E74E-ABFA-8D0D18AD80CD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6E06F46-CE14-E73B-525D-4D02AA4EE2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96C0E4D-E336-B0CD-8F97-82653E54A8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DBB0-6E86-1F4A-9056-49B47FD18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18893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98955D-3920-7377-7E14-ED0F21C1CD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26DB64D-6195-DFA4-EB68-23128F9438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75693-053D-E74E-ABFA-8D0D18AD80CD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064E5D8-52F9-63C0-86AA-5CD93D540C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D8934AA-BFB6-17D0-C329-C88109161A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DBB0-6E86-1F4A-9056-49B47FD18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6707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AED0176-13BB-82C9-289E-9C1DBBB79C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75693-053D-E74E-ABFA-8D0D18AD80CD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EA19F5C-00B7-8D54-58C3-16E25B6A96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E81180A-4C71-697D-3B55-AAE726B66D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DBB0-6E86-1F4A-9056-49B47FD18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21565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4D6F38-F048-4F86-F2AF-50B5B96D20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70507B-88CE-434A-903A-7FAE0A08A6C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89F150A-1195-1A86-8068-FD1C9488B1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A4A124-7C74-F314-9E01-81B5D0355C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75693-053D-E74E-ABFA-8D0D18AD80CD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5E69F8-CA57-0651-06C0-5511608A42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D63F2FA-3A18-7EC3-6459-ACB38EEEBC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DBB0-6E86-1F4A-9056-49B47FD18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42564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B22D82-20CB-1D27-2E2B-4711244C2B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5F5D8F1-47E0-F2AB-EFF3-4056E8B1ED5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81C6424-7657-EAB2-B990-4FF45C039A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F23423D-B2BE-63D7-8CFE-D232D7BBE4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75693-053D-E74E-ABFA-8D0D18AD80CD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A88AF0-0AD4-5F22-E58E-E7E5E1A0F8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BFEA411-882C-CAD6-F6DA-0B49146D2A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DBB0-6E86-1F4A-9056-49B47FD18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72703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21CAC1D-C0CE-F5EF-DAD8-D868BE2910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703ACE0-447E-478F-9E60-FDC133087A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1032B7-67DA-D63F-487F-63CB12A7101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5C75693-053D-E74E-ABFA-8D0D18AD80CD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C4AFC1-69FD-EF01-3AB7-9C0FBCBC380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A0A6D1-4C9B-B04E-AAC1-247FAEAD2E9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637DBB0-6E86-1F4A-9056-49B47FD18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8373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>
            <a:extLst>
              <a:ext uri="{FF2B5EF4-FFF2-40B4-BE49-F238E27FC236}">
                <a16:creationId xmlns:a16="http://schemas.microsoft.com/office/drawing/2014/main" id="{227EDAF1-7831-6434-E4A2-E1969092C1E3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3200" b="1" dirty="0">
                <a:solidFill>
                  <a:schemeClr val="bg1"/>
                </a:solidFill>
              </a:rPr>
              <a:t>Neuroimaging findings in children and young adults with chronic kidney diseas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1DFA724-9B9A-DE10-6A5E-E77658A46A35}"/>
              </a:ext>
            </a:extLst>
          </p:cNvPr>
          <p:cNvSpPr txBox="1"/>
          <p:nvPr/>
        </p:nvSpPr>
        <p:spPr>
          <a:xfrm>
            <a:off x="-118752" y="1189759"/>
            <a:ext cx="123107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sz="1600" dirty="0">
                <a:solidFill>
                  <a:schemeClr val="bg1"/>
                </a:solidFill>
                <a:latin typeface="Abadi" panose="020B0604020104020204" pitchFamily="34" charset="0"/>
                <a:cs typeface="Arial" panose="020B0604020202020204" pitchFamily="34" charset="0"/>
              </a:rPr>
              <a:t>This systematic review explored neuroimaging in pediatric CKD aiming to characterize brain outcomes in pediatric CKD.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84407E4-009E-18F9-F577-012EBA0C2DCD}"/>
              </a:ext>
            </a:extLst>
          </p:cNvPr>
          <p:cNvSpPr txBox="1"/>
          <p:nvPr/>
        </p:nvSpPr>
        <p:spPr>
          <a:xfrm>
            <a:off x="77537" y="1836090"/>
            <a:ext cx="28700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:</a:t>
            </a:r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4FD3264-49C8-F3C0-72CA-226741457876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Kayumba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4C9205C-A86F-9C77-8D11-CED5F158EC7B}"/>
              </a:ext>
            </a:extLst>
          </p:cNvPr>
          <p:cNvSpPr txBox="1"/>
          <p:nvPr/>
        </p:nvSpPr>
        <p:spPr>
          <a:xfrm>
            <a:off x="13447" y="5746152"/>
            <a:ext cx="7460639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solidFill>
                  <a:schemeClr val="bg1"/>
                </a:solidFill>
              </a:rPr>
              <a:t>CONCLUSION</a:t>
            </a:r>
            <a:r>
              <a:rPr lang="en-GB" sz="1600" dirty="0">
                <a:solidFill>
                  <a:schemeClr val="bg1"/>
                </a:solidFill>
              </a:rPr>
              <a:t>: Evidence that </a:t>
            </a:r>
            <a:r>
              <a:rPr lang="en-GB" sz="1600" dirty="0">
                <a:solidFill>
                  <a:schemeClr val="bg1"/>
                </a:solidFill>
                <a:latin typeface="Abadi" panose="020B0604020104020204" pitchFamily="34" charset="0"/>
                <a:cs typeface="Arial" panose="020B0604020202020204" pitchFamily="34" charset="0"/>
              </a:rPr>
              <a:t>brain structure and function in paediatric CKD are impaired even from early CKD stages is compelling. A global mechanism for this remains unclear. Future work should prioritize longitudinal models of assessment using uniform groups based on age, disease severity, aetiology and treatment. </a:t>
            </a:r>
            <a:endParaRPr lang="en-GB" sz="1600" dirty="0">
              <a:solidFill>
                <a:schemeClr val="bg1"/>
              </a:solidFill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1C6E01E6-B5C0-9DA9-5515-0BF58BF70BF8}"/>
              </a:ext>
            </a:extLst>
          </p:cNvPr>
          <p:cNvSpPr/>
          <p:nvPr/>
        </p:nvSpPr>
        <p:spPr>
          <a:xfrm>
            <a:off x="453903" y="3202346"/>
            <a:ext cx="1698327" cy="608350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463 CKD patients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F09ECEF4-CDB8-545B-A150-B47349DB6036}"/>
              </a:ext>
            </a:extLst>
          </p:cNvPr>
          <p:cNvSpPr/>
          <p:nvPr/>
        </p:nvSpPr>
        <p:spPr>
          <a:xfrm>
            <a:off x="453903" y="3842391"/>
            <a:ext cx="1698327" cy="608350"/>
          </a:xfrm>
          <a:prstGeom prst="rect">
            <a:avLst/>
          </a:prstGeom>
          <a:solidFill>
            <a:srgbClr val="65AA0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274 unaffected comparators</a:t>
            </a:r>
          </a:p>
        </p:txBody>
      </p: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213D59D2-5E17-BA83-C97D-FBBD580885EF}"/>
              </a:ext>
            </a:extLst>
          </p:cNvPr>
          <p:cNvCxnSpPr/>
          <p:nvPr/>
        </p:nvCxnSpPr>
        <p:spPr>
          <a:xfrm flipV="1">
            <a:off x="2231743" y="3824142"/>
            <a:ext cx="715833" cy="1"/>
          </a:xfrm>
          <a:prstGeom prst="straightConnector1">
            <a:avLst/>
          </a:prstGeom>
          <a:ln w="57150">
            <a:solidFill>
              <a:srgbClr val="DA0082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Freeform: Shape 46">
            <a:extLst>
              <a:ext uri="{FF2B5EF4-FFF2-40B4-BE49-F238E27FC236}">
                <a16:creationId xmlns:a16="http://schemas.microsoft.com/office/drawing/2014/main" id="{FE919770-F803-79B4-C937-C84BD50AAABF}"/>
              </a:ext>
            </a:extLst>
          </p:cNvPr>
          <p:cNvSpPr/>
          <p:nvPr/>
        </p:nvSpPr>
        <p:spPr>
          <a:xfrm>
            <a:off x="1201681" y="2301470"/>
            <a:ext cx="353992" cy="69444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2A5E4EAB-8295-79BA-2848-7D8263F921EB}"/>
              </a:ext>
            </a:extLst>
          </p:cNvPr>
          <p:cNvGrpSpPr/>
          <p:nvPr/>
        </p:nvGrpSpPr>
        <p:grpSpPr>
          <a:xfrm>
            <a:off x="3029086" y="2073472"/>
            <a:ext cx="9181575" cy="3501339"/>
            <a:chOff x="3010425" y="2073472"/>
            <a:chExt cx="9181575" cy="3501339"/>
          </a:xfrm>
        </p:grpSpPr>
        <p:pic>
          <p:nvPicPr>
            <p:cNvPr id="31" name="Picture 30" descr="A red blood cells in a vein&#10;&#10;AI-generated content may be incorrect.">
              <a:extLst>
                <a:ext uri="{FF2B5EF4-FFF2-40B4-BE49-F238E27FC236}">
                  <a16:creationId xmlns:a16="http://schemas.microsoft.com/office/drawing/2014/main" id="{65BDB429-1578-F001-B35C-CA2E5EF0C64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114185">
              <a:off x="7846533" y="2857462"/>
              <a:ext cx="1146076" cy="421552"/>
            </a:xfrm>
            <a:prstGeom prst="rect">
              <a:avLst/>
            </a:prstGeom>
          </p:spPr>
        </p:pic>
        <p:pic>
          <p:nvPicPr>
            <p:cNvPr id="33" name="Picture 32" descr="A diagram of a brain&#10;&#10;AI-generated content may be incorrect.">
              <a:extLst>
                <a:ext uri="{FF2B5EF4-FFF2-40B4-BE49-F238E27FC236}">
                  <a16:creationId xmlns:a16="http://schemas.microsoft.com/office/drawing/2014/main" id="{DFEDC57C-3209-7325-7D4E-32ACD12538A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10425" y="4555620"/>
              <a:ext cx="1628273" cy="777659"/>
            </a:xfrm>
            <a:prstGeom prst="rect">
              <a:avLst/>
            </a:prstGeom>
          </p:spPr>
        </p:pic>
        <p:pic>
          <p:nvPicPr>
            <p:cNvPr id="39" name="Picture 38" descr="A red line art of a brain and clock&#10;&#10;AI-generated content may be incorrect.">
              <a:extLst>
                <a:ext uri="{FF2B5EF4-FFF2-40B4-BE49-F238E27FC236}">
                  <a16:creationId xmlns:a16="http://schemas.microsoft.com/office/drawing/2014/main" id="{0BDD8C6C-DCFB-F1B4-BC7D-ABC1A43B940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49815" y="4121802"/>
              <a:ext cx="942583" cy="813600"/>
            </a:xfrm>
            <a:prstGeom prst="rect">
              <a:avLst/>
            </a:prstGeom>
          </p:spPr>
        </p:pic>
        <p:pic>
          <p:nvPicPr>
            <p:cNvPr id="41" name="Picture 40" descr="A red and white neuron system&#10;&#10;AI-generated content may be incorrect.">
              <a:extLst>
                <a:ext uri="{FF2B5EF4-FFF2-40B4-BE49-F238E27FC236}">
                  <a16:creationId xmlns:a16="http://schemas.microsoft.com/office/drawing/2014/main" id="{8D17AA26-66F0-EFCA-55E7-11282CC206D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71642" y="3182819"/>
              <a:ext cx="1091877" cy="1131390"/>
            </a:xfrm>
            <a:prstGeom prst="rect">
              <a:avLst/>
            </a:prstGeom>
          </p:spPr>
        </p:pic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69216F40-06BD-793C-8E12-20F004CA90D8}"/>
                </a:ext>
              </a:extLst>
            </p:cNvPr>
            <p:cNvSpPr txBox="1"/>
            <p:nvPr/>
          </p:nvSpPr>
          <p:spPr>
            <a:xfrm>
              <a:off x="4833161" y="2303495"/>
              <a:ext cx="2412044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Abnormal cerebral and cerebellar gray matter volume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1840C2E1-DE2A-DD0D-ED8C-3EACCCB91C91}"/>
                </a:ext>
              </a:extLst>
            </p:cNvPr>
            <p:cNvSpPr txBox="1"/>
            <p:nvPr/>
          </p:nvSpPr>
          <p:spPr>
            <a:xfrm>
              <a:off x="4760965" y="3431862"/>
              <a:ext cx="2920422" cy="6595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White matter integrity was impaired from early CKD stages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800F41EC-B597-0B67-3B07-D06CE30F1CA1}"/>
                </a:ext>
              </a:extLst>
            </p:cNvPr>
            <p:cNvSpPr txBox="1"/>
            <p:nvPr/>
          </p:nvSpPr>
          <p:spPr>
            <a:xfrm>
              <a:off x="9271579" y="2610215"/>
              <a:ext cx="2920421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Increase in cerebral blood flow in the precuneus linked to executive function deficits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7F1DB6E3-3425-91A4-DA04-3D3289C92D17}"/>
                </a:ext>
              </a:extLst>
            </p:cNvPr>
            <p:cNvSpPr txBox="1"/>
            <p:nvPr/>
          </p:nvSpPr>
          <p:spPr>
            <a:xfrm>
              <a:off x="4801767" y="4526154"/>
              <a:ext cx="2806073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Silent brain white matter lesions in up to 79% of patient on dialysis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1D7ED96F-287F-BA45-F8A1-56349812272D}"/>
                </a:ext>
              </a:extLst>
            </p:cNvPr>
            <p:cNvSpPr txBox="1"/>
            <p:nvPr/>
          </p:nvSpPr>
          <p:spPr>
            <a:xfrm>
              <a:off x="9271579" y="4119395"/>
              <a:ext cx="2806073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Longer reactivity and response time in visual-spatial working memory tasks</a:t>
              </a:r>
            </a:p>
          </p:txBody>
        </p:sp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id="{1FF9C636-CF21-D5BD-6919-BE93E3E70303}"/>
                </a:ext>
              </a:extLst>
            </p:cNvPr>
            <p:cNvCxnSpPr>
              <a:cxnSpLocks/>
            </p:cNvCxnSpPr>
            <p:nvPr/>
          </p:nvCxnSpPr>
          <p:spPr>
            <a:xfrm>
              <a:off x="7719303" y="2073472"/>
              <a:ext cx="0" cy="3501339"/>
            </a:xfrm>
            <a:prstGeom prst="line">
              <a:avLst/>
            </a:prstGeom>
            <a:ln/>
          </p:spPr>
          <p:style>
            <a:lnRef idx="2">
              <a:schemeClr val="accent6"/>
            </a:lnRef>
            <a:fillRef idx="0">
              <a:schemeClr val="accent6"/>
            </a:fillRef>
            <a:effectRef idx="1">
              <a:schemeClr val="accent6"/>
            </a:effectRef>
            <a:fontRef idx="minor">
              <a:schemeClr val="tx1"/>
            </a:fontRef>
          </p:style>
        </p:cxnSp>
        <p:pic>
          <p:nvPicPr>
            <p:cNvPr id="63" name="Picture 62" descr="A pink brain with black lines&#10;&#10;AI-generated content may be incorrect.">
              <a:extLst>
                <a:ext uri="{FF2B5EF4-FFF2-40B4-BE49-F238E27FC236}">
                  <a16:creationId xmlns:a16="http://schemas.microsoft.com/office/drawing/2014/main" id="{735AD70B-1877-22D4-65A1-8E424C8B174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86656" y="2269123"/>
              <a:ext cx="960052" cy="737359"/>
            </a:xfrm>
            <a:prstGeom prst="rect">
              <a:avLst/>
            </a:prstGeom>
          </p:spPr>
        </p:pic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54AC0D06-DA2B-8514-E716-87E428D844FF}"/>
              </a:ext>
            </a:extLst>
          </p:cNvPr>
          <p:cNvSpPr/>
          <p:nvPr/>
        </p:nvSpPr>
        <p:spPr>
          <a:xfrm>
            <a:off x="140512" y="4731658"/>
            <a:ext cx="2476330" cy="377365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16 Studies; 0-25 years</a:t>
            </a:r>
          </a:p>
        </p:txBody>
      </p:sp>
    </p:spTree>
    <p:extLst>
      <p:ext uri="{BB962C8B-B14F-4D97-AF65-F5344CB8AC3E}">
        <p14:creationId xmlns:p14="http://schemas.microsoft.com/office/powerpoint/2010/main" val="33348847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154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badi</vt:lpstr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Promesse Kayumba (pk1n22)</dc:creator>
  <cp:lastModifiedBy>Laycock, Joseph</cp:lastModifiedBy>
  <cp:revision>2</cp:revision>
  <dcterms:created xsi:type="dcterms:W3CDTF">2025-10-24T17:02:50Z</dcterms:created>
  <dcterms:modified xsi:type="dcterms:W3CDTF">2025-11-24T12:48:51Z</dcterms:modified>
</cp:coreProperties>
</file>